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2160" y="767880"/>
            <a:ext cx="511488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B1C282-136B-4470-8A8C-1AC65721E13C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37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88FFBC-341E-4F5C-A4EC-99298C908DD8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0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76EB51-F0C0-4D8C-84D6-54A6D8F857E6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5E12BC-6CA8-44A0-956F-E91C2144AD1C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6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C13A34-EC9F-4C12-83C3-F3DC754C012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49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44980C-04EF-40F7-A688-804B263888E4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15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Espace réservé du numéro de diapositive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C309C3-B3DF-4DB5-8D4A-782E5B7480C1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EF2FD-E7AE-4E49-BFA1-9F254BF4E7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7C73B4-925D-4ACE-86EA-3DC3333CDA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229A0-9E31-48D9-B3F4-2031FA5856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A724A-B854-45CD-8B99-7FC386D11B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7FFE0-D455-4400-A439-0B9CE75B75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B372E-9C64-4F6E-83C2-972CA11DCA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30D1E-57EA-438F-B5B2-8ED022CE95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89C12-064D-48DC-8FC6-4B4E4785E2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18D06-FA0A-49E2-93E1-73773E5EC8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41AB5-4121-4F07-AFD6-637E37BB8D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5E777-B816-4333-B6B0-578DAE9DF7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1F25E-6BE6-428E-B6D1-9634A4D0F6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44E00C-1D9B-49B8-B910-4F717263752E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image" Target="../media/image24.png"/><Relationship Id="rId10" Type="http://schemas.openxmlformats.org/officeDocument/2006/relationships/image" Target="../media/image25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1"/>
          <p:cNvGrpSpPr/>
          <p:nvPr/>
        </p:nvGrpSpPr>
        <p:grpSpPr>
          <a:xfrm>
            <a:off x="196920" y="115920"/>
            <a:ext cx="8319960" cy="6602400"/>
            <a:chOff x="196920" y="115920"/>
            <a:chExt cx="8319960" cy="6602400"/>
          </a:xfrm>
        </p:grpSpPr>
        <p:sp>
          <p:nvSpPr>
            <p:cNvPr id="49" name="ZoneTexte 18"/>
            <p:cNvSpPr/>
            <p:nvPr/>
          </p:nvSpPr>
          <p:spPr>
            <a:xfrm>
              <a:off x="3355200" y="115920"/>
              <a:ext cx="2397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Supplementary</a:t>
              </a:r>
              <a:r>
                <a:rPr b="0" lang="fr-FR" sz="1800" spc="-1" strike="noStrike">
                  <a:solidFill>
                    <a:srgbClr val="000000"/>
                  </a:solidFill>
                  <a:latin typeface="Calibri"/>
                </a:rPr>
                <a:t> Figure 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ZoneTexte 6"/>
            <p:cNvSpPr/>
            <p:nvPr/>
          </p:nvSpPr>
          <p:spPr>
            <a:xfrm>
              <a:off x="227160" y="54432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ZoneTexte 9"/>
            <p:cNvSpPr/>
            <p:nvPr/>
          </p:nvSpPr>
          <p:spPr>
            <a:xfrm>
              <a:off x="1977480" y="549360"/>
              <a:ext cx="10036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Calibri"/>
                </a:rPr>
                <a:t>PC12 cell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ZoneTexte 11"/>
            <p:cNvSpPr/>
            <p:nvPr/>
          </p:nvSpPr>
          <p:spPr>
            <a:xfrm rot="16200000">
              <a:off x="-438480" y="1597320"/>
              <a:ext cx="157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% of differentia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ZoneTexte 7"/>
            <p:cNvSpPr/>
            <p:nvPr/>
          </p:nvSpPr>
          <p:spPr>
            <a:xfrm>
              <a:off x="4426920" y="52596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ZoneTexte 10"/>
            <p:cNvSpPr/>
            <p:nvPr/>
          </p:nvSpPr>
          <p:spPr>
            <a:xfrm>
              <a:off x="5826240" y="544320"/>
              <a:ext cx="1674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600" spc="-1" strike="noStrike">
                  <a:solidFill>
                    <a:srgbClr val="000000"/>
                  </a:solidFill>
                  <a:latin typeface="Calibri"/>
                </a:rPr>
                <a:t>FGF1 </a:t>
              </a:r>
              <a:r>
                <a:rPr b="0" lang="fr-FR" sz="1600" spc="-1" strike="noStrike" baseline="30000">
                  <a:solidFill>
                    <a:srgbClr val="000000"/>
                  </a:solidFill>
                  <a:latin typeface="Calibri"/>
                </a:rPr>
                <a:t>WT</a:t>
              </a:r>
              <a:r>
                <a:rPr b="0" lang="fr-FR" sz="1600" spc="-1" strike="noStrike">
                  <a:solidFill>
                    <a:srgbClr val="000000"/>
                  </a:solidFill>
                  <a:latin typeface="Calibri"/>
                </a:rPr>
                <a:t> PC12 cell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Graphique 5" descr=""/>
            <p:cNvPicPr/>
            <p:nvPr/>
          </p:nvPicPr>
          <p:blipFill>
            <a:blip r:embed="rId1"/>
            <a:stretch/>
          </p:blipFill>
          <p:spPr>
            <a:xfrm>
              <a:off x="1516320" y="3733560"/>
              <a:ext cx="5812200" cy="2984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ZoneTexte 8"/>
            <p:cNvSpPr/>
            <p:nvPr/>
          </p:nvSpPr>
          <p:spPr>
            <a:xfrm>
              <a:off x="1033920" y="3713760"/>
              <a:ext cx="30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ZoneTexte 21"/>
            <p:cNvSpPr/>
            <p:nvPr/>
          </p:nvSpPr>
          <p:spPr>
            <a:xfrm rot="16200000">
              <a:off x="3769560" y="1621080"/>
              <a:ext cx="157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% of differentia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ZoneTexte 22"/>
            <p:cNvSpPr/>
            <p:nvPr/>
          </p:nvSpPr>
          <p:spPr>
            <a:xfrm rot="16200000">
              <a:off x="645480" y="4455000"/>
              <a:ext cx="157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% of differentia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9" name="Graphique 13" descr=""/>
            <p:cNvPicPr/>
            <p:nvPr/>
          </p:nvPicPr>
          <p:blipFill>
            <a:blip r:embed="rId2"/>
            <a:stretch/>
          </p:blipFill>
          <p:spPr>
            <a:xfrm>
              <a:off x="352800" y="797040"/>
              <a:ext cx="4124520" cy="2984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Graphique 17" descr=""/>
            <p:cNvPicPr/>
            <p:nvPr/>
          </p:nvPicPr>
          <p:blipFill>
            <a:blip r:embed="rId3"/>
            <a:stretch/>
          </p:blipFill>
          <p:spPr>
            <a:xfrm>
              <a:off x="4550760" y="779040"/>
              <a:ext cx="3966120" cy="29422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ZoneTexte 34"/>
          <p:cNvSpPr/>
          <p:nvPr/>
        </p:nvSpPr>
        <p:spPr>
          <a:xfrm>
            <a:off x="3358800" y="115920"/>
            <a:ext cx="239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Figur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2" name="Groupe 15"/>
          <p:cNvGrpSpPr/>
          <p:nvPr/>
        </p:nvGrpSpPr>
        <p:grpSpPr>
          <a:xfrm>
            <a:off x="324000" y="1276200"/>
            <a:ext cx="8545320" cy="4165920"/>
            <a:chOff x="324000" y="1276200"/>
            <a:chExt cx="8545320" cy="4165920"/>
          </a:xfrm>
        </p:grpSpPr>
        <p:pic>
          <p:nvPicPr>
            <p:cNvPr id="63" name="Picture 5" descr=""/>
            <p:cNvPicPr/>
            <p:nvPr/>
          </p:nvPicPr>
          <p:blipFill>
            <a:blip r:embed="rId1"/>
            <a:srcRect l="20764" t="25384" r="29259" b="0"/>
            <a:stretch/>
          </p:blipFill>
          <p:spPr>
            <a:xfrm>
              <a:off x="345240" y="1609920"/>
              <a:ext cx="1619640" cy="1606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ZoneTexte 2"/>
            <p:cNvSpPr/>
            <p:nvPr/>
          </p:nvSpPr>
          <p:spPr>
            <a:xfrm>
              <a:off x="581400" y="1276200"/>
              <a:ext cx="1105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contro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Picture 6" descr=""/>
            <p:cNvPicPr/>
            <p:nvPr/>
          </p:nvPicPr>
          <p:blipFill>
            <a:blip r:embed="rId2"/>
            <a:srcRect l="28462" t="1189" r="21555" b="24510"/>
            <a:stretch/>
          </p:blipFill>
          <p:spPr>
            <a:xfrm>
              <a:off x="2052000" y="1609920"/>
              <a:ext cx="1619640" cy="160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ZoneTexte 8"/>
            <p:cNvSpPr/>
            <p:nvPr/>
          </p:nvSpPr>
          <p:spPr>
            <a:xfrm>
              <a:off x="2309040" y="1276200"/>
              <a:ext cx="1143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+ rFGF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7" name="Picture 7" descr=""/>
            <p:cNvPicPr/>
            <p:nvPr/>
          </p:nvPicPr>
          <p:blipFill>
            <a:blip r:embed="rId3"/>
            <a:srcRect l="43076" t="0" r="7642" b="25236"/>
            <a:stretch/>
          </p:blipFill>
          <p:spPr>
            <a:xfrm>
              <a:off x="324000" y="3297960"/>
              <a:ext cx="1619640" cy="162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ZoneTexte 10"/>
            <p:cNvSpPr/>
            <p:nvPr/>
          </p:nvSpPr>
          <p:spPr>
            <a:xfrm>
              <a:off x="407520" y="4921920"/>
              <a:ext cx="145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+ PD1730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ZoneTexte 11"/>
            <p:cNvSpPr/>
            <p:nvPr/>
          </p:nvSpPr>
          <p:spPr>
            <a:xfrm>
              <a:off x="2304360" y="4921920"/>
              <a:ext cx="11520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+ rFGF1 + PD1730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0" name="Picture 8" descr=""/>
            <p:cNvPicPr/>
            <p:nvPr/>
          </p:nvPicPr>
          <p:blipFill>
            <a:blip r:embed="rId4"/>
            <a:srcRect l="27262" t="0" r="23278" b="24462"/>
            <a:stretch/>
          </p:blipFill>
          <p:spPr>
            <a:xfrm>
              <a:off x="2052000" y="3297960"/>
              <a:ext cx="1619640" cy="164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9" descr=""/>
            <p:cNvPicPr/>
            <p:nvPr/>
          </p:nvPicPr>
          <p:blipFill>
            <a:blip r:embed="rId5"/>
            <a:srcRect l="28462" t="17708" r="21759" b="7996"/>
            <a:stretch/>
          </p:blipFill>
          <p:spPr>
            <a:xfrm>
              <a:off x="3788640" y="1609920"/>
              <a:ext cx="1619640" cy="1606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ZoneTexte 14"/>
            <p:cNvSpPr/>
            <p:nvPr/>
          </p:nvSpPr>
          <p:spPr>
            <a:xfrm>
              <a:off x="4083840" y="1276200"/>
              <a:ext cx="109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WT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3" name="Picture 10" descr=""/>
            <p:cNvPicPr/>
            <p:nvPr/>
          </p:nvPicPr>
          <p:blipFill>
            <a:blip r:embed="rId6"/>
            <a:srcRect l="30003" t="3022" r="19734" b="22981"/>
            <a:stretch/>
          </p:blipFill>
          <p:spPr>
            <a:xfrm>
              <a:off x="3780000" y="3297960"/>
              <a:ext cx="1619640" cy="1584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ZoneTexte 16"/>
            <p:cNvSpPr/>
            <p:nvPr/>
          </p:nvSpPr>
          <p:spPr>
            <a:xfrm>
              <a:off x="3996000" y="4921920"/>
              <a:ext cx="12240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WT </a:t>
              </a: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+ PD1730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5" name="Picture 12" descr=""/>
            <p:cNvPicPr/>
            <p:nvPr/>
          </p:nvPicPr>
          <p:blipFill>
            <a:blip r:embed="rId7"/>
            <a:srcRect l="41530" t="23955" r="7918" b="1743"/>
            <a:stretch/>
          </p:blipFill>
          <p:spPr>
            <a:xfrm>
              <a:off x="5508000" y="1609920"/>
              <a:ext cx="1619640" cy="158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ZoneTexte 19"/>
            <p:cNvSpPr/>
            <p:nvPr/>
          </p:nvSpPr>
          <p:spPr>
            <a:xfrm>
              <a:off x="5751000" y="1276200"/>
              <a:ext cx="1215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7" name="Picture 20" descr=""/>
            <p:cNvPicPr/>
            <p:nvPr/>
          </p:nvPicPr>
          <p:blipFill>
            <a:blip r:embed="rId8"/>
            <a:srcRect l="23182" t="0" r="27650" b="25740"/>
            <a:stretch/>
          </p:blipFill>
          <p:spPr>
            <a:xfrm>
              <a:off x="5519520" y="3297960"/>
              <a:ext cx="1619640" cy="162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ZoneTexte 28"/>
            <p:cNvSpPr/>
            <p:nvPr/>
          </p:nvSpPr>
          <p:spPr>
            <a:xfrm>
              <a:off x="5652000" y="4921920"/>
              <a:ext cx="12960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A </a:t>
              </a: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+ PD1730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9" name="Picture 21" descr=""/>
            <p:cNvPicPr/>
            <p:nvPr/>
          </p:nvPicPr>
          <p:blipFill>
            <a:blip r:embed="rId9"/>
            <a:srcRect l="42423" t="25337" r="7788" b="0"/>
            <a:stretch/>
          </p:blipFill>
          <p:spPr>
            <a:xfrm>
              <a:off x="7249680" y="1609920"/>
              <a:ext cx="1619640" cy="1613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" name="ZoneTexte 30"/>
            <p:cNvSpPr/>
            <p:nvPr/>
          </p:nvSpPr>
          <p:spPr>
            <a:xfrm>
              <a:off x="7428240" y="1276200"/>
              <a:ext cx="1220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1" name="Picture 22" descr=""/>
            <p:cNvPicPr/>
            <p:nvPr/>
          </p:nvPicPr>
          <p:blipFill>
            <a:blip r:embed="rId10"/>
            <a:srcRect l="50337" t="22289" r="0" b="2715"/>
            <a:stretch/>
          </p:blipFill>
          <p:spPr>
            <a:xfrm>
              <a:off x="7236000" y="3297960"/>
              <a:ext cx="1619640" cy="162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ZoneTexte 32"/>
            <p:cNvSpPr/>
            <p:nvPr/>
          </p:nvSpPr>
          <p:spPr>
            <a:xfrm>
              <a:off x="7428240" y="4921920"/>
              <a:ext cx="12960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PC12 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D </a:t>
              </a: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+ PD1730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Connecteur droit 36"/>
            <p:cNvSpPr/>
            <p:nvPr/>
          </p:nvSpPr>
          <p:spPr>
            <a:xfrm>
              <a:off x="1686240" y="3104640"/>
              <a:ext cx="162360" cy="0"/>
            </a:xfrm>
            <a:prstGeom prst="line">
              <a:avLst/>
            </a:prstGeom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ZoneTexte 3"/>
          <p:cNvSpPr/>
          <p:nvPr/>
        </p:nvSpPr>
        <p:spPr>
          <a:xfrm>
            <a:off x="3358800" y="115920"/>
            <a:ext cx="239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5" name="Groupe 8"/>
          <p:cNvGrpSpPr/>
          <p:nvPr/>
        </p:nvGrpSpPr>
        <p:grpSpPr>
          <a:xfrm>
            <a:off x="539640" y="1496880"/>
            <a:ext cx="7980480" cy="3672000"/>
            <a:chOff x="539640" y="1496880"/>
            <a:chExt cx="7980480" cy="3672000"/>
          </a:xfrm>
        </p:grpSpPr>
        <p:pic>
          <p:nvPicPr>
            <p:cNvPr id="86" name="Graphique 2" descr=""/>
            <p:cNvPicPr/>
            <p:nvPr/>
          </p:nvPicPr>
          <p:blipFill>
            <a:blip r:embed="rId1"/>
            <a:stretch/>
          </p:blipFill>
          <p:spPr>
            <a:xfrm>
              <a:off x="3090240" y="1496880"/>
              <a:ext cx="5429880" cy="36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ZoneTexte 4"/>
            <p:cNvSpPr/>
            <p:nvPr/>
          </p:nvSpPr>
          <p:spPr>
            <a:xfrm>
              <a:off x="632880" y="1543320"/>
              <a:ext cx="3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ZoneTexte 5"/>
            <p:cNvSpPr/>
            <p:nvPr/>
          </p:nvSpPr>
          <p:spPr>
            <a:xfrm>
              <a:off x="3159720" y="152532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9" name="Graphique 7" descr=""/>
            <p:cNvPicPr/>
            <p:nvPr/>
          </p:nvPicPr>
          <p:blipFill>
            <a:blip r:embed="rId2"/>
            <a:stretch/>
          </p:blipFill>
          <p:spPr>
            <a:xfrm>
              <a:off x="539640" y="1521000"/>
              <a:ext cx="2453040" cy="35625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5" descr=""/>
          <p:cNvPicPr/>
          <p:nvPr/>
        </p:nvPicPr>
        <p:blipFill>
          <a:blip r:embed="rId1"/>
          <a:srcRect l="24499" t="7961" r="25300" b="42702"/>
          <a:stretch/>
        </p:blipFill>
        <p:spPr>
          <a:xfrm>
            <a:off x="2886120" y="1222200"/>
            <a:ext cx="1827000" cy="2386080"/>
          </a:xfrm>
          <a:prstGeom prst="rect">
            <a:avLst/>
          </a:prstGeom>
          <a:ln w="0">
            <a:noFill/>
          </a:ln>
        </p:spPr>
      </p:pic>
      <p:sp>
        <p:nvSpPr>
          <p:cNvPr id="91" name="ZoneTexte 1"/>
          <p:cNvSpPr/>
          <p:nvPr/>
        </p:nvSpPr>
        <p:spPr>
          <a:xfrm>
            <a:off x="3361320" y="115920"/>
            <a:ext cx="271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Figure 4 (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ZoneTexte 15"/>
          <p:cNvSpPr/>
          <p:nvPr/>
        </p:nvSpPr>
        <p:spPr>
          <a:xfrm>
            <a:off x="1508400" y="836640"/>
            <a:ext cx="72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ZoneTexte 16"/>
          <p:cNvSpPr/>
          <p:nvPr/>
        </p:nvSpPr>
        <p:spPr>
          <a:xfrm>
            <a:off x="3495960" y="836640"/>
            <a:ext cx="610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FGF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ZoneTexte 17"/>
          <p:cNvSpPr/>
          <p:nvPr/>
        </p:nvSpPr>
        <p:spPr>
          <a:xfrm>
            <a:off x="5039280" y="836640"/>
            <a:ext cx="138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FGF1 + Ab FGF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ZoneTexte 18"/>
          <p:cNvSpPr/>
          <p:nvPr/>
        </p:nvSpPr>
        <p:spPr>
          <a:xfrm>
            <a:off x="7123320" y="836640"/>
            <a:ext cx="101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FGF1 + Ig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ZoneTexte 20"/>
          <p:cNvSpPr/>
          <p:nvPr/>
        </p:nvSpPr>
        <p:spPr>
          <a:xfrm>
            <a:off x="264240" y="225576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PC1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ZoneTexte 21"/>
          <p:cNvSpPr/>
          <p:nvPr/>
        </p:nvSpPr>
        <p:spPr>
          <a:xfrm>
            <a:off x="192240" y="475632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FGF1</a:t>
            </a:r>
            <a:r>
              <a:rPr b="0" lang="fr-FR" sz="14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ZoneTexte 22"/>
          <p:cNvSpPr/>
          <p:nvPr/>
        </p:nvSpPr>
        <p:spPr>
          <a:xfrm>
            <a:off x="1508400" y="6145200"/>
            <a:ext cx="72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ZoneTexte 23"/>
          <p:cNvSpPr/>
          <p:nvPr/>
        </p:nvSpPr>
        <p:spPr>
          <a:xfrm>
            <a:off x="3573000" y="614520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De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ZoneTexte 24"/>
          <p:cNvSpPr/>
          <p:nvPr/>
        </p:nvSpPr>
        <p:spPr>
          <a:xfrm>
            <a:off x="5115960" y="6145200"/>
            <a:ext cx="1227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Dex + Ab FGF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ZoneTexte 25"/>
          <p:cNvSpPr/>
          <p:nvPr/>
        </p:nvSpPr>
        <p:spPr>
          <a:xfrm>
            <a:off x="7199280" y="6145200"/>
            <a:ext cx="86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Dex + Ig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ZoneTexte 26"/>
          <p:cNvSpPr/>
          <p:nvPr/>
        </p:nvSpPr>
        <p:spPr>
          <a:xfrm>
            <a:off x="364320" y="77616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Picture 6" descr=""/>
          <p:cNvPicPr/>
          <p:nvPr/>
        </p:nvPicPr>
        <p:blipFill>
          <a:blip r:embed="rId2"/>
          <a:srcRect l="44671" t="35464" r="3466" b="14973"/>
          <a:stretch/>
        </p:blipFill>
        <p:spPr>
          <a:xfrm>
            <a:off x="4834080" y="1214280"/>
            <a:ext cx="1790640" cy="239076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8" descr=""/>
          <p:cNvPicPr/>
          <p:nvPr/>
        </p:nvPicPr>
        <p:blipFill>
          <a:blip r:embed="rId3"/>
          <a:srcRect l="0" t="0" r="50020" b="49517"/>
          <a:stretch/>
        </p:blipFill>
        <p:spPr>
          <a:xfrm>
            <a:off x="6742080" y="1214280"/>
            <a:ext cx="1781280" cy="239076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9" descr=""/>
          <p:cNvPicPr/>
          <p:nvPr/>
        </p:nvPicPr>
        <p:blipFill>
          <a:blip r:embed="rId4"/>
          <a:srcRect l="50020" t="0" r="0" b="50015"/>
          <a:stretch/>
        </p:blipFill>
        <p:spPr>
          <a:xfrm>
            <a:off x="968400" y="3714840"/>
            <a:ext cx="1800360" cy="239076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10" descr=""/>
          <p:cNvPicPr/>
          <p:nvPr/>
        </p:nvPicPr>
        <p:blipFill>
          <a:blip r:embed="rId5"/>
          <a:srcRect l="44351" t="41797" r="5168" b="8414"/>
          <a:stretch/>
        </p:blipFill>
        <p:spPr>
          <a:xfrm>
            <a:off x="2889360" y="3714840"/>
            <a:ext cx="1823760" cy="239076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11" descr=""/>
          <p:cNvPicPr/>
          <p:nvPr/>
        </p:nvPicPr>
        <p:blipFill>
          <a:blip r:embed="rId6"/>
          <a:srcRect l="50220" t="24894" r="0" b="25090"/>
          <a:stretch/>
        </p:blipFill>
        <p:spPr>
          <a:xfrm>
            <a:off x="4834080" y="3714840"/>
            <a:ext cx="1790640" cy="239076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12" descr=""/>
          <p:cNvPicPr/>
          <p:nvPr/>
        </p:nvPicPr>
        <p:blipFill>
          <a:blip r:embed="rId7"/>
          <a:srcRect l="33574" t="10796" r="17408" b="39219"/>
          <a:stretch/>
        </p:blipFill>
        <p:spPr>
          <a:xfrm>
            <a:off x="6750000" y="3714840"/>
            <a:ext cx="1765440" cy="239076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4" descr=""/>
          <p:cNvPicPr/>
          <p:nvPr/>
        </p:nvPicPr>
        <p:blipFill>
          <a:blip r:embed="rId8"/>
          <a:srcRect l="50020" t="0" r="0" b="50015"/>
          <a:stretch/>
        </p:blipFill>
        <p:spPr>
          <a:xfrm>
            <a:off x="968400" y="1217520"/>
            <a:ext cx="1800360" cy="239076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6" descr=""/>
          <p:cNvPicPr/>
          <p:nvPr/>
        </p:nvPicPr>
        <p:blipFill>
          <a:blip r:embed="rId9"/>
          <a:srcRect l="44671" t="35464" r="3466" b="14973"/>
          <a:stretch/>
        </p:blipFill>
        <p:spPr>
          <a:xfrm>
            <a:off x="4834080" y="1217520"/>
            <a:ext cx="1790640" cy="239076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8" descr=""/>
          <p:cNvPicPr/>
          <p:nvPr/>
        </p:nvPicPr>
        <p:blipFill>
          <a:blip r:embed="rId10"/>
          <a:srcRect l="0" t="0" r="50020" b="49517"/>
          <a:stretch/>
        </p:blipFill>
        <p:spPr>
          <a:xfrm>
            <a:off x="6742080" y="1217520"/>
            <a:ext cx="1781280" cy="2390760"/>
          </a:xfrm>
          <a:prstGeom prst="rect">
            <a:avLst/>
          </a:prstGeom>
          <a:ln w="0">
            <a:noFill/>
          </a:ln>
        </p:spPr>
      </p:pic>
      <p:sp>
        <p:nvSpPr>
          <p:cNvPr id="112" name="Connecteur droit 3"/>
          <p:cNvSpPr/>
          <p:nvPr/>
        </p:nvSpPr>
        <p:spPr>
          <a:xfrm>
            <a:off x="2376360" y="3500280"/>
            <a:ext cx="28764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ZoneTexte 19"/>
          <p:cNvSpPr/>
          <p:nvPr/>
        </p:nvSpPr>
        <p:spPr>
          <a:xfrm>
            <a:off x="3361320" y="115920"/>
            <a:ext cx="271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 Figure 4 (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4" name="Groupe 1"/>
          <p:cNvGrpSpPr/>
          <p:nvPr/>
        </p:nvGrpSpPr>
        <p:grpSpPr>
          <a:xfrm>
            <a:off x="187200" y="776160"/>
            <a:ext cx="8345520" cy="5676840"/>
            <a:chOff x="187200" y="776160"/>
            <a:chExt cx="8345520" cy="5676840"/>
          </a:xfrm>
        </p:grpSpPr>
        <p:sp>
          <p:nvSpPr>
            <p:cNvPr id="115" name="ZoneTexte 5"/>
            <p:cNvSpPr/>
            <p:nvPr/>
          </p:nvSpPr>
          <p:spPr>
            <a:xfrm>
              <a:off x="187200" y="2297520"/>
              <a:ext cx="856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ZoneTexte 7"/>
            <p:cNvSpPr/>
            <p:nvPr/>
          </p:nvSpPr>
          <p:spPr>
            <a:xfrm>
              <a:off x="1653840" y="614592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ZoneTexte 8"/>
            <p:cNvSpPr/>
            <p:nvPr/>
          </p:nvSpPr>
          <p:spPr>
            <a:xfrm>
              <a:off x="3658320" y="6145920"/>
              <a:ext cx="45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ZoneTexte 9"/>
            <p:cNvSpPr/>
            <p:nvPr/>
          </p:nvSpPr>
          <p:spPr>
            <a:xfrm>
              <a:off x="5146560" y="6145920"/>
              <a:ext cx="1227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 + Ab FGF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ZoneTexte 10"/>
            <p:cNvSpPr/>
            <p:nvPr/>
          </p:nvSpPr>
          <p:spPr>
            <a:xfrm>
              <a:off x="7201800" y="6145920"/>
              <a:ext cx="86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 + IgG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ZoneTexte 11"/>
            <p:cNvSpPr/>
            <p:nvPr/>
          </p:nvSpPr>
          <p:spPr>
            <a:xfrm>
              <a:off x="187200" y="4745880"/>
              <a:ext cx="856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FGF1</a:t>
              </a:r>
              <a:r>
                <a:rPr b="0" lang="fr-FR" sz="1400" spc="-1" strike="noStrike" baseline="30000">
                  <a:solidFill>
                    <a:srgbClr val="000000"/>
                  </a:solidFill>
                  <a:latin typeface="Calibri"/>
                </a:rPr>
                <a:t>S130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ZoneTexte 12"/>
            <p:cNvSpPr/>
            <p:nvPr/>
          </p:nvSpPr>
          <p:spPr>
            <a:xfrm>
              <a:off x="1653840" y="909000"/>
              <a:ext cx="720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ZoneTexte 13"/>
            <p:cNvSpPr/>
            <p:nvPr/>
          </p:nvSpPr>
          <p:spPr>
            <a:xfrm>
              <a:off x="3658320" y="909000"/>
              <a:ext cx="45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ZoneTexte 14"/>
            <p:cNvSpPr/>
            <p:nvPr/>
          </p:nvSpPr>
          <p:spPr>
            <a:xfrm>
              <a:off x="5146560" y="909000"/>
              <a:ext cx="1227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 + Ab FGF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ZoneTexte 15"/>
            <p:cNvSpPr/>
            <p:nvPr/>
          </p:nvSpPr>
          <p:spPr>
            <a:xfrm>
              <a:off x="7201800" y="909000"/>
              <a:ext cx="865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Calibri"/>
                </a:rPr>
                <a:t>Dex + IgG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25" name="Picture 2" descr=""/>
            <p:cNvPicPr/>
            <p:nvPr/>
          </p:nvPicPr>
          <p:blipFill>
            <a:blip r:embed="rId1"/>
            <a:stretch/>
          </p:blipFill>
          <p:spPr>
            <a:xfrm rot="16200000">
              <a:off x="820080" y="1553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6" name="Picture 5" descr=""/>
            <p:cNvPicPr/>
            <p:nvPr/>
          </p:nvPicPr>
          <p:blipFill>
            <a:blip r:embed="rId2"/>
            <a:stretch/>
          </p:blipFill>
          <p:spPr>
            <a:xfrm rot="5400000">
              <a:off x="6440040" y="1553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7" name="Picture 6" descr=""/>
            <p:cNvPicPr/>
            <p:nvPr/>
          </p:nvPicPr>
          <p:blipFill>
            <a:blip r:embed="rId3"/>
            <a:stretch/>
          </p:blipFill>
          <p:spPr>
            <a:xfrm rot="5400000">
              <a:off x="819720" y="4001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8" name="Picture 7" descr=""/>
            <p:cNvPicPr/>
            <p:nvPr/>
          </p:nvPicPr>
          <p:blipFill>
            <a:blip r:embed="rId4"/>
            <a:stretch/>
          </p:blipFill>
          <p:spPr>
            <a:xfrm rot="5400000">
              <a:off x="2692080" y="4001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8" descr=""/>
            <p:cNvPicPr/>
            <p:nvPr/>
          </p:nvPicPr>
          <p:blipFill>
            <a:blip r:embed="rId5"/>
            <a:stretch/>
          </p:blipFill>
          <p:spPr>
            <a:xfrm rot="16200000">
              <a:off x="4566240" y="4001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9" descr=""/>
            <p:cNvPicPr/>
            <p:nvPr/>
          </p:nvPicPr>
          <p:blipFill>
            <a:blip r:embed="rId6"/>
            <a:stretch/>
          </p:blipFill>
          <p:spPr>
            <a:xfrm rot="16200000">
              <a:off x="6440400" y="4001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10" descr=""/>
            <p:cNvPicPr/>
            <p:nvPr/>
          </p:nvPicPr>
          <p:blipFill>
            <a:blip r:embed="rId7"/>
            <a:stretch/>
          </p:blipFill>
          <p:spPr>
            <a:xfrm rot="16200000">
              <a:off x="2692440" y="1553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11" descr=""/>
            <p:cNvPicPr/>
            <p:nvPr/>
          </p:nvPicPr>
          <p:blipFill>
            <a:blip r:embed="rId8"/>
            <a:stretch/>
          </p:blipFill>
          <p:spPr>
            <a:xfrm rot="5400000">
              <a:off x="4565880" y="1553040"/>
              <a:ext cx="2387520" cy="1796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ZoneTexte 20"/>
            <p:cNvSpPr/>
            <p:nvPr/>
          </p:nvSpPr>
          <p:spPr>
            <a:xfrm>
              <a:off x="367200" y="776160"/>
              <a:ext cx="308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Connecteur droit 21"/>
            <p:cNvSpPr/>
            <p:nvPr/>
          </p:nvSpPr>
          <p:spPr>
            <a:xfrm>
              <a:off x="1188000" y="1377000"/>
              <a:ext cx="288000" cy="0"/>
            </a:xfrm>
            <a:prstGeom prst="line">
              <a:avLst/>
            </a:prstGeom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Rectangle 1"/>
          <p:cNvSpPr/>
          <p:nvPr/>
        </p:nvSpPr>
        <p:spPr>
          <a:xfrm>
            <a:off x="611280" y="336600"/>
            <a:ext cx="7632720" cy="66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Legen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1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) PC12 cells were treated with 0, 10, 25, 50 or 100 nM of PD173074 (an inhibitor of FGF receptors) in the absence or presence of 100 ng/ml of recombinant FGF1 and 10 µg/ml Heparin (FGF1 + Heparin is noted rFGF1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)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C12 cells were treated with 0, 10, 25, 50 or 100 nM of PD173074 in the absence or presence of dexamethason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) Native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D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C12 cells were treated with 50 nM PD173074, in the presence or not of rFGF1 (PC12 cells) or in the presence of 5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-7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dexamethasone (FGF1 transfected PC12 cells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or A-C, cell morphology was observed after 3 days of treatment and the percentage of cells presenting long and ramified neuritis was determined for each condi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2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ative,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D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C12 cells were cultured in the presence or absence of 50 nM PD173074, with or without rFGF1 (PC12 cells) or in the presence of 5.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-7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dexamethasone (FGF1 transfected PC12 cells). After 3 days of treatment, cell morphology was observed by microscopy. Representative pictures are presented. Scale bar:50 µ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3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) PC12 cells were cultured in 1µ-Slide 8 well ibiTreat (Ibidi GmbH) in the absence or presence of 25 ng/ml of recombinant FGF1 and 10 µg/ml Heparin (FGF1 + Heparin is noted rFGF1), 12.5 or 25 µg/ml of human FGF1 antibody (AF232, R&amp;D systems, noted Ab FGF1) or 25 µg/ml of normal goat IgG control (AB-108-C, R&amp;D systems, noted IgG). After three days of treatment, cells were fixed and permeabilized before performing an actin staining (Rhodamine-Phalloidin, Sigma, 1/200) in order to quantify the percentage of differentiation according to morphological criteria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i.e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cells presenting long and ramified neuriti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) Native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D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C12 cells were either cultured in the absence or presence of 25 ng/ml rFGF1 and 10 µg/ml of Heparin for native PC12 cells, or treated with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-6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dexamethasone for FGF1 transfected PC12 cells. When mentioned, 25 µg/ml of Ab FGF1 or IgG were added. After two days of treatment and actin staining, cell morphology was observed by microscopy and the percentage of differentiation was determined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Supplementary figure 4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ative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WT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A),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FGF1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S130D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(B) PC12 cells were cultured either in the absence or presence of 25 ng/ml rFGF1 and 10 µg/ml of Heparin for native PC12 cells, or in the presence of 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-6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 dexamethasone for FGF1 transfected PC12 cells. Cells were additionally treated or not with25 µg/ml of Ab FGF1 or IgG. After two days of treatment and actin staining, cell morphology was observed by microscopy. Representative pictures are presented. Scale bar: 50 µm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4T19:15:38Z</dcterms:created>
  <dc:creator>Flore Renaud</dc:creator>
  <dc:description/>
  <dc:language>en-US</dc:language>
  <cp:lastModifiedBy>Satish.d</cp:lastModifiedBy>
  <cp:lastPrinted>2015-08-31T09:16:44Z</cp:lastPrinted>
  <dcterms:modified xsi:type="dcterms:W3CDTF">2016-01-25T16:17:45Z</dcterms:modified>
  <cp:revision>89</cp:revision>
  <dc:subject/>
  <dc:title>Présentation PowerPoint</dc:title>
</cp:coreProperties>
</file>